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66" r:id="rId2"/>
  </p:sldIdLst>
  <p:sldSz cx="7559675" cy="100441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29"/>
  </p:normalViewPr>
  <p:slideViewPr>
    <p:cSldViewPr snapToGrid="0" snapToObjects="1">
      <p:cViewPr varScale="1">
        <p:scale>
          <a:sx n="78" d="100"/>
          <a:sy n="78" d="100"/>
        </p:scale>
        <p:origin x="18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643794"/>
            <a:ext cx="6425724" cy="3496839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275485"/>
            <a:ext cx="5669756" cy="2425002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1/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52758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1/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21432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34756"/>
            <a:ext cx="1630055" cy="8511921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34756"/>
            <a:ext cx="4795669" cy="8511921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1/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15186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1/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46339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504056"/>
            <a:ext cx="6520220" cy="4178071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721654"/>
            <a:ext cx="6520220" cy="2197149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1/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97109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673780"/>
            <a:ext cx="3212862" cy="637289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673780"/>
            <a:ext cx="3212862" cy="637289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1/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45734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34758"/>
            <a:ext cx="6520220" cy="194139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462203"/>
            <a:ext cx="3198096" cy="1206688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668891"/>
            <a:ext cx="3198096" cy="539638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462203"/>
            <a:ext cx="3213847" cy="1206688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668891"/>
            <a:ext cx="3213847" cy="539638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1/2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76827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1/2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85349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1/2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85071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9608"/>
            <a:ext cx="2438192" cy="234362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446169"/>
            <a:ext cx="3827085" cy="713783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013234"/>
            <a:ext cx="2438192" cy="5582389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1/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54555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9608"/>
            <a:ext cx="2438192" cy="234362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446169"/>
            <a:ext cx="3827085" cy="713783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013234"/>
            <a:ext cx="2438192" cy="5582389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51190-DB9E-5347-9B43-72AC3DFF4111}" type="datetimeFigureOut">
              <a:rPr kumimoji="1" lang="zh-CN" altLang="en-US" smtClean="0"/>
              <a:t>2021/1/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37722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34758"/>
            <a:ext cx="6520220" cy="19413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673780"/>
            <a:ext cx="6520220" cy="63728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309407"/>
            <a:ext cx="1700927" cy="5347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51190-DB9E-5347-9B43-72AC3DFF4111}" type="datetimeFigureOut">
              <a:rPr kumimoji="1" lang="zh-CN" altLang="en-US" smtClean="0"/>
              <a:t>2021/1/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309407"/>
            <a:ext cx="2551390" cy="5347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309407"/>
            <a:ext cx="1700927" cy="5347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D0C9B7-C7C6-4947-8B49-73B2F1A9ABF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49193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xmlns="" id="{D59173D1-985C-9B4F-83C1-FB9740230A1F}"/>
              </a:ext>
            </a:extLst>
          </p:cNvPr>
          <p:cNvGraphicFramePr>
            <a:graphicFrameLocks noGrp="1"/>
          </p:cNvGraphicFramePr>
          <p:nvPr/>
        </p:nvGraphicFramePr>
        <p:xfrm>
          <a:off x="596626" y="1071105"/>
          <a:ext cx="6099721" cy="7901901"/>
        </p:xfrm>
        <a:graphic>
          <a:graphicData uri="http://schemas.openxmlformats.org/drawingml/2006/table">
            <a:tbl>
              <a:tblPr>
                <a:tableStyleId>{F2DE63D5-997A-4646-A377-4702673A728D}</a:tableStyleId>
              </a:tblPr>
              <a:tblGrid>
                <a:gridCol w="1416206">
                  <a:extLst>
                    <a:ext uri="{9D8B030D-6E8A-4147-A177-3AD203B41FA5}">
                      <a16:colId xmlns:a16="http://schemas.microsoft.com/office/drawing/2014/main" xmlns="" val="665229979"/>
                    </a:ext>
                  </a:extLst>
                </a:gridCol>
                <a:gridCol w="936703">
                  <a:extLst>
                    <a:ext uri="{9D8B030D-6E8A-4147-A177-3AD203B41FA5}">
                      <a16:colId xmlns:a16="http://schemas.microsoft.com/office/drawing/2014/main" xmlns="" val="1026255970"/>
                    </a:ext>
                  </a:extLst>
                </a:gridCol>
                <a:gridCol w="936703">
                  <a:extLst>
                    <a:ext uri="{9D8B030D-6E8A-4147-A177-3AD203B41FA5}">
                      <a16:colId xmlns:a16="http://schemas.microsoft.com/office/drawing/2014/main" xmlns="" val="2693154136"/>
                    </a:ext>
                  </a:extLst>
                </a:gridCol>
                <a:gridCol w="936703">
                  <a:extLst>
                    <a:ext uri="{9D8B030D-6E8A-4147-A177-3AD203B41FA5}">
                      <a16:colId xmlns:a16="http://schemas.microsoft.com/office/drawing/2014/main" xmlns="" val="3958449045"/>
                    </a:ext>
                  </a:extLst>
                </a:gridCol>
                <a:gridCol w="936703">
                  <a:extLst>
                    <a:ext uri="{9D8B030D-6E8A-4147-A177-3AD203B41FA5}">
                      <a16:colId xmlns:a16="http://schemas.microsoft.com/office/drawing/2014/main" xmlns="" val="2414829971"/>
                    </a:ext>
                  </a:extLst>
                </a:gridCol>
                <a:gridCol w="936703">
                  <a:extLst>
                    <a:ext uri="{9D8B030D-6E8A-4147-A177-3AD203B41FA5}">
                      <a16:colId xmlns:a16="http://schemas.microsoft.com/office/drawing/2014/main" xmlns="" val="575719842"/>
                    </a:ext>
                  </a:extLst>
                </a:gridCol>
              </a:tblGrid>
              <a:tr h="504000"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</a:rPr>
                        <a:t>Housekeeping Genes</a:t>
                      </a: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1" u="none" strike="noStrike" dirty="0">
                        <a:solidFill>
                          <a:srgbClr val="505050"/>
                        </a:solidFill>
                        <a:effectLst/>
                        <a:latin typeface="Helvetica" pitchFamily="2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1" u="none" strike="noStrike" dirty="0">
                        <a:solidFill>
                          <a:srgbClr val="505050"/>
                        </a:solidFill>
                        <a:effectLst/>
                        <a:latin typeface="Helvetica" pitchFamily="2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23562762"/>
                  </a:ext>
                </a:extLst>
              </a:tr>
              <a:tr h="504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等线" panose="02010600030101010101" pitchFamily="2" charset="-122"/>
                        </a:rPr>
                        <a:t>Datasets</a:t>
                      </a: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ACTB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PP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TB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PSMB4</a:t>
                      </a:r>
                      <a:endParaRPr lang="en-US" sz="1100" b="0" i="1" u="none" strike="noStrike">
                        <a:solidFill>
                          <a:srgbClr val="505050"/>
                        </a:solidFill>
                        <a:effectLst/>
                        <a:latin typeface="Helvetica" pitchFamily="2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VPS29</a:t>
                      </a:r>
                      <a:endParaRPr lang="en-US" sz="1100" b="0" i="1" u="none" strike="noStrike" dirty="0">
                        <a:solidFill>
                          <a:srgbClr val="505050"/>
                        </a:solidFill>
                        <a:effectLst/>
                        <a:latin typeface="Helvetica" pitchFamily="2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50100479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 dirty="0">
                          <a:effectLst/>
                        </a:rPr>
                        <a:t>GSE119169-splee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</a:rPr>
                        <a:t>0.09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3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2420810423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 dirty="0">
                          <a:effectLst/>
                        </a:rPr>
                        <a:t>GSE37532-L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4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3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4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2555693982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E-MTAB-7961-splee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7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4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2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3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</a:rPr>
                        <a:t>-0.17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2440957725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GSE20366-intersti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4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9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4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25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821220835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GSE64909-B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3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1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2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1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505569203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GSE37532-V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3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7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4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572949760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E-MTAB-7961-kinde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5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3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5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5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656036202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GSE50096-spleen2w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7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1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1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2974951448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GSE50096-spleen4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5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7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1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23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196246709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 dirty="0">
                          <a:effectLst/>
                        </a:rPr>
                        <a:t>E-MTAB-7961-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2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9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29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947380489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 dirty="0">
                          <a:effectLst/>
                        </a:rPr>
                        <a:t>E-MTAB-7961-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24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49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803400736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GSE50096-muscle2w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5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1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13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5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493144915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GSE50096-muscle4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1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1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23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9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3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580495249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GSE116347-spleenB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7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3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27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2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2308929956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GSE116347-spleenMC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2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4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5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5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08058296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GSE116347-spleenCT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4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2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4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959704043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GSE120280-spleenTC-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4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3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1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945836798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GSE139372-melanom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7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5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29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4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0745058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GSE120280-TC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5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5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3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4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4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2752037011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 dirty="0">
                          <a:effectLst/>
                        </a:rPr>
                        <a:t>GSE89225-breast cance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3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4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3055560460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 dirty="0">
                          <a:effectLst/>
                        </a:rPr>
                        <a:t>GSE116347-tumorB1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7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59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5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4268958690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 dirty="0">
                          <a:effectLst/>
                        </a:rPr>
                        <a:t>GSE116347-tumorMC3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2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34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2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1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4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820454686"/>
                  </a:ext>
                </a:extLst>
              </a:tr>
              <a:tr h="267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 dirty="0">
                          <a:effectLst/>
                        </a:rPr>
                        <a:t>GSE116347-tumorCT2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27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3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</a:rPr>
                        <a:t>-0.52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54452164"/>
                  </a:ext>
                </a:extLst>
              </a:tr>
              <a:tr h="1843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Ma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7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20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8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59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5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2023373477"/>
                  </a:ext>
                </a:extLst>
              </a:tr>
              <a:tr h="1843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mi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27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56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3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29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5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391940155"/>
                  </a:ext>
                </a:extLst>
              </a:tr>
              <a:tr h="1843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mea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3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7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-0.05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2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13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378508495"/>
                  </a:ext>
                </a:extLst>
              </a:tr>
              <a:tr h="1843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S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</a:rPr>
                        <a:t>0.30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</a:rPr>
                        <a:t>0.20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</a:rPr>
                        <a:t>0.18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</a:rPr>
                        <a:t>0.22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</a:rPr>
                        <a:t>0.29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5546" marR="5546" marT="554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20233909"/>
                  </a:ext>
                </a:extLst>
              </a:tr>
            </a:tbl>
          </a:graphicData>
        </a:graphic>
      </p:graphicFrame>
      <p:sp>
        <p:nvSpPr>
          <p:cNvPr id="10" name="文本框 9">
            <a:extLst>
              <a:ext uri="{FF2B5EF4-FFF2-40B4-BE49-F238E27FC236}">
                <a16:creationId xmlns:a16="http://schemas.microsoft.com/office/drawing/2014/main" xmlns="" id="{C04D42C6-38DA-BB4F-8E22-D4613BC101CB}"/>
              </a:ext>
            </a:extLst>
          </p:cNvPr>
          <p:cNvSpPr txBox="1"/>
          <p:nvPr/>
        </p:nvSpPr>
        <p:spPr>
          <a:xfrm>
            <a:off x="481430" y="122799"/>
            <a:ext cx="659681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13"/>
            <a:r>
              <a:rPr kumimoji="1" lang="en-US" altLang="zh-CN" sz="1200" dirty="0">
                <a:solidFill>
                  <a:prstClr val="black"/>
                </a:solidFill>
                <a:latin typeface="Calibri" panose="020F0502020204030204"/>
                <a:ea typeface="等线" panose="02010600030101010101" pitchFamily="2" charset="-122"/>
              </a:rPr>
              <a:t>Supplementary table </a:t>
            </a:r>
            <a:r>
              <a:rPr kumimoji="1" lang="en-US" altLang="zh-CN" sz="1200" dirty="0" smtClean="0">
                <a:solidFill>
                  <a:prstClr val="black"/>
                </a:solidFill>
                <a:latin typeface="Calibri" panose="020F0502020204030204"/>
                <a:ea typeface="等线" panose="02010600030101010101" pitchFamily="2" charset="-122"/>
              </a:rPr>
              <a:t>1. </a:t>
            </a:r>
            <a:r>
              <a:rPr kumimoji="1" lang="en-US" altLang="zh-CN" sz="1200" dirty="0">
                <a:solidFill>
                  <a:prstClr val="black"/>
                </a:solidFill>
                <a:latin typeface="Calibri" panose="020F0502020204030204"/>
                <a:ea typeface="等线" panose="02010600030101010101" pitchFamily="2" charset="-122"/>
              </a:rPr>
              <a:t>Five housekeeping genes was chosen</a:t>
            </a:r>
            <a:r>
              <a:rPr kumimoji="1" lang="zh-CN" altLang="en-US" sz="1200" dirty="0">
                <a:solidFill>
                  <a:prstClr val="black"/>
                </a:solidFill>
                <a:latin typeface="Calibri" panose="020F0502020204030204"/>
                <a:ea typeface="等线" panose="02010600030101010101" pitchFamily="2" charset="-122"/>
              </a:rPr>
              <a:t> </a:t>
            </a:r>
            <a:r>
              <a:rPr kumimoji="1" lang="en-US" altLang="zh-CN" sz="1200" dirty="0">
                <a:solidFill>
                  <a:prstClr val="black"/>
                </a:solidFill>
                <a:latin typeface="Calibri" panose="020F0502020204030204"/>
                <a:ea typeface="等线" panose="02010600030101010101" pitchFamily="2" charset="-122"/>
              </a:rPr>
              <a:t>from publication of Eisenberg et al (</a:t>
            </a:r>
            <a:r>
              <a:rPr kumimoji="1" lang="en-US" altLang="zh-CN" sz="1200" dirty="0">
                <a:solidFill>
                  <a:prstClr val="black"/>
                </a:solidFill>
              </a:rPr>
              <a:t>PMID 23810203</a:t>
            </a:r>
            <a:r>
              <a:rPr kumimoji="1" lang="en-US" altLang="zh-CN" sz="1200" dirty="0">
                <a:solidFill>
                  <a:prstClr val="black"/>
                </a:solidFill>
                <a:latin typeface="Calibri" panose="020F0502020204030204"/>
                <a:ea typeface="等线" panose="02010600030101010101" pitchFamily="2" charset="-122"/>
              </a:rPr>
              <a:t>) and we </a:t>
            </a:r>
            <a:r>
              <a:rPr kumimoji="1" lang="en-US" altLang="zh-CN" sz="1200" dirty="0">
                <a:solidFill>
                  <a:prstClr val="black"/>
                </a:solidFill>
              </a:rPr>
              <a:t>reported previously (PMID 32179051). The mean log2FC of housekeeping genes in all the datasets used in this study varied from -0.07 to 0.13. Therefore, these datasets are of high quality.</a:t>
            </a:r>
            <a:endParaRPr kumimoji="1" lang="zh-CN" altLang="en-US" sz="1200" dirty="0">
              <a:solidFill>
                <a:prstClr val="black"/>
              </a:solidFill>
              <a:latin typeface="Calibri" panose="020F0502020204030204"/>
              <a:ea typeface="等线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602789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2</TotalTime>
  <Words>286</Words>
  <Application>Microsoft Office PowerPoint</Application>
  <PresentationFormat>自定义</PresentationFormat>
  <Paragraphs>17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Helvetica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qe</dc:creator>
  <cp:lastModifiedBy>nidon</cp:lastModifiedBy>
  <cp:revision>12</cp:revision>
  <dcterms:created xsi:type="dcterms:W3CDTF">2020-09-18T19:42:05Z</dcterms:created>
  <dcterms:modified xsi:type="dcterms:W3CDTF">2021-01-02T04:10:44Z</dcterms:modified>
</cp:coreProperties>
</file>